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4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B4B105-B3F0-262A-956B-5F354D1DED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85E74C4-3FB8-0527-340D-6B78BF8672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808DC2-FB0C-64B9-8DD5-928859505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80EEBA-A207-BE4D-A7AE-2FC4292A2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7BE01A-65E5-5296-E41B-74E1C0B3D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6435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3A0520-BB7E-B0A9-5BA6-486ADD6060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12A225-AA02-261C-680E-5343FE1B5C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F473F9-A0A9-E0E5-52EC-7EF2B2552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F14F1B-7F19-1361-1192-8D5DABB1A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900325-EBD6-65C5-F526-9FB760AF4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0238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5D8DB7-76A5-1FE9-D3B5-3465D54BD2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4D0038-4621-970F-BD35-DCC7AF7BA7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5C1CF3-7791-A96A-B6CA-FB5C844F6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563CA8-B333-276E-B461-75BA2E524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D46682-618F-8FB1-81C2-926E6B98E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3943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10CB8F-4D78-8B8E-1534-35E146737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E12EE6-3856-0D90-E285-56AE0B2D7E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F58133-FB1B-614D-42B9-CD6A8B0EAF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771461-F85B-D9F0-3C97-73AEF95EB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315ED9-490C-5818-EAE0-C9CDAB36D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7789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90C2D6-8D81-1A80-DEC7-58DD4025B2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634765-3EF0-7B92-D836-3864E0A5DB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35482C-4A55-D665-E15E-F4C5C0DE5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FBE9FE-522F-DBBC-A32C-DB4674C01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FCA13B-78DC-3D18-72C0-7A9D9EA02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0439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8F290A-7823-5BCF-098A-401E6CF52E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E83161-865D-3BAD-3673-9596911ACA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90C4CC-A644-04F6-61ED-C2BF8C5B71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1AAC42-680B-D9C1-EAEC-BC8F21E95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867D2A-7656-5653-C67E-A0C8C24675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B77A84-19E7-1CE0-570F-7489D5202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3578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4CF22D-25A5-870C-97E6-46E66ECD30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03D879-ABB0-4670-CE13-B993859530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3C8F95-B577-A3FF-8468-B156EA927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F705BB-25FD-8B46-9804-382780CC90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2F075B-27E6-EA46-C1FF-D42BB6B4DF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0D2EB5-F95A-1A35-2C16-43A231231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4B74AD-AD2D-97F7-3895-DA0431F90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877B4F-7B79-0C4D-5E3B-58FA5BB20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6402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C78AB6-26DE-5B0A-57C7-684C7CD74F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6B34D84-0D08-D95B-4D4F-EC0839B09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C932FEB-E832-4C91-4C85-67B3E97F2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7E7C30-A086-DB9A-5819-391B07254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1488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722324-0229-8E28-F5D6-0970ADF6C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CB5757B-4001-0362-9FDF-966FE7432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90B1C2-3A54-AFE2-2B9C-3E33C5637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621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FB364-0AA2-D252-429F-E52EE96FCE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D01FDB-0D0B-0458-C9BE-3D5A30BB80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CEFA15-5E9F-ACEF-F5C9-F865B0A8B8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E58DDA-72D0-8972-9FB5-4205FBB5F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37BA15-9ECF-3D57-1478-9B72CBE81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3FDD0A-D9F7-BB67-A0D9-D64650F84A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704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3551D5-E2CA-C0C4-3E60-9E4A99F40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E1E5A07-A4B0-8D38-3E23-5E12D519BF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AE3A1B-8D93-AF41-D43B-2756421420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D96E62-EDC0-1EF0-028B-1F2DFFF0A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2C8852-8038-2000-4689-16AC58B28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0BD68F-AF10-1422-20B2-6C3304C7F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0411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5CFC250-9A5E-F5F9-3203-CC414BAAA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D9C899-9350-6018-F92F-4E673CEC0D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6F2D01-77CB-CD94-9A63-38EA3F8DCC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3DE9CD-11FE-482B-B8B0-CD26967D9D31}" type="datetimeFigureOut">
              <a:rPr lang="en-GB" smtClean="0"/>
              <a:t>18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22188F-C84F-ED40-A267-D59D573501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D61229-A8F8-2D81-B8BB-B6E6577F06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ED7379-DB37-4BB5-87CD-E29A7E4CD1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9576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4" name="Picture 20">
            <a:extLst>
              <a:ext uri="{FF2B5EF4-FFF2-40B4-BE49-F238E27FC236}">
                <a16:creationId xmlns:a16="http://schemas.microsoft.com/office/drawing/2014/main" id="{5C32FA20-A6D5-4300-C33A-F154D44C357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6" t="20091"/>
          <a:stretch/>
        </p:blipFill>
        <p:spPr bwMode="auto">
          <a:xfrm>
            <a:off x="258184" y="1466794"/>
            <a:ext cx="2869290" cy="17260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6" name="Picture 22">
            <a:extLst>
              <a:ext uri="{FF2B5EF4-FFF2-40B4-BE49-F238E27FC236}">
                <a16:creationId xmlns:a16="http://schemas.microsoft.com/office/drawing/2014/main" id="{833289CA-93D7-AEB7-4C8A-FD826020392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6" t="18292"/>
          <a:stretch/>
        </p:blipFill>
        <p:spPr bwMode="auto">
          <a:xfrm>
            <a:off x="3277253" y="1427917"/>
            <a:ext cx="2869290" cy="1764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8" name="Picture 24">
            <a:extLst>
              <a:ext uri="{FF2B5EF4-FFF2-40B4-BE49-F238E27FC236}">
                <a16:creationId xmlns:a16="http://schemas.microsoft.com/office/drawing/2014/main" id="{4F01864D-0B9C-9A9D-A1C5-59E2F06286C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6" t="20091"/>
          <a:stretch/>
        </p:blipFill>
        <p:spPr bwMode="auto">
          <a:xfrm>
            <a:off x="6296322" y="1466794"/>
            <a:ext cx="2869291" cy="17260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0" name="Picture 26">
            <a:extLst>
              <a:ext uri="{FF2B5EF4-FFF2-40B4-BE49-F238E27FC236}">
                <a16:creationId xmlns:a16="http://schemas.microsoft.com/office/drawing/2014/main" id="{40FFBAD2-1183-940F-3D2C-97340647E24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6" t="20091" b="1"/>
          <a:stretch/>
        </p:blipFill>
        <p:spPr bwMode="auto">
          <a:xfrm>
            <a:off x="9293699" y="1466794"/>
            <a:ext cx="2869292" cy="17260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2" name="Picture 28">
            <a:extLst>
              <a:ext uri="{FF2B5EF4-FFF2-40B4-BE49-F238E27FC236}">
                <a16:creationId xmlns:a16="http://schemas.microsoft.com/office/drawing/2014/main" id="{4E64D431-FC5A-EFD4-297A-028F310503B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9" t="20092"/>
          <a:stretch/>
        </p:blipFill>
        <p:spPr bwMode="auto">
          <a:xfrm>
            <a:off x="265501" y="3467878"/>
            <a:ext cx="2890982" cy="17260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4" name="Picture 30">
            <a:extLst>
              <a:ext uri="{FF2B5EF4-FFF2-40B4-BE49-F238E27FC236}">
                <a16:creationId xmlns:a16="http://schemas.microsoft.com/office/drawing/2014/main" id="{52E5A6EF-2DAD-0728-6922-1D8F7EBBA3D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9" t="18291"/>
          <a:stretch/>
        </p:blipFill>
        <p:spPr bwMode="auto">
          <a:xfrm>
            <a:off x="3284570" y="3429000"/>
            <a:ext cx="2890983" cy="1764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6" name="Picture 32">
            <a:extLst>
              <a:ext uri="{FF2B5EF4-FFF2-40B4-BE49-F238E27FC236}">
                <a16:creationId xmlns:a16="http://schemas.microsoft.com/office/drawing/2014/main" id="{1FA68B3B-09A9-51D5-A1B9-25F2CBE9C08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9" t="18291"/>
          <a:stretch/>
        </p:blipFill>
        <p:spPr bwMode="auto">
          <a:xfrm>
            <a:off x="6303639" y="3429000"/>
            <a:ext cx="2890983" cy="17649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8" name="Picture 34">
            <a:extLst>
              <a:ext uri="{FF2B5EF4-FFF2-40B4-BE49-F238E27FC236}">
                <a16:creationId xmlns:a16="http://schemas.microsoft.com/office/drawing/2014/main" id="{AC7491F7-2422-35A7-21CA-31AC0DEEC42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9" t="18291"/>
          <a:stretch/>
        </p:blipFill>
        <p:spPr bwMode="auto">
          <a:xfrm>
            <a:off x="9301016" y="3428998"/>
            <a:ext cx="2890984" cy="17649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mc:AlternateContent xmlns:mc="http://schemas.openxmlformats.org/markup-compatibility/2006">
        <mc:Choice xmlns:a14="http://schemas.microsoft.com/office/drawing/2010/main" Requires="a14"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62AD190D-D5D0-1A3D-D646-7249CD22F517}"/>
                  </a:ext>
                </a:extLst>
              </p:cNvPr>
              <p:cNvSpPr txBox="1"/>
              <p:nvPr/>
            </p:nvSpPr>
            <p:spPr>
              <a:xfrm rot="16200000">
                <a:off x="-435165" y="1979502"/>
                <a:ext cx="118107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GB" sz="1100" b="1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𝐋𝐨𝐠</m:t>
                          </m:r>
                        </m:e>
                        <m:sub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𝟏𝟎</m:t>
                          </m:r>
                        </m:sub>
                      </m:sSub>
                      <m:d>
                        <m:dPr>
                          <m:ctrlPr>
                            <a:rPr lang="en-GB" sz="1100" b="1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>
                            <m:sSubPr>
                              <m:ctrlPr>
                                <a:rPr lang="en-GB" sz="1100" b="1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𝐩</m:t>
                              </m:r>
                            </m:e>
                            <m:sub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𝐆</m:t>
                              </m:r>
                              <m:r>
                                <a:rPr lang="en-GB" sz="1100" b="1" i="0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𝐈𝐅𝐓</m:t>
                              </m:r>
                            </m:sub>
                          </m:sSub>
                        </m:e>
                      </m:d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62AD190D-D5D0-1A3D-D646-7249CD22F51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-435165" y="1979502"/>
                <a:ext cx="1181073" cy="261610"/>
              </a:xfrm>
              <a:prstGeom prst="rect">
                <a:avLst/>
              </a:prstGeom>
              <a:blipFill>
                <a:blip r:embed="rId10"/>
                <a:stretch>
                  <a:fillRect r="-2326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EFB0FD9-5A1B-A1C7-FE27-1DC6F0FECC9A}"/>
                  </a:ext>
                </a:extLst>
              </p:cNvPr>
              <p:cNvSpPr txBox="1"/>
              <p:nvPr/>
            </p:nvSpPr>
            <p:spPr>
              <a:xfrm rot="16200000">
                <a:off x="2583922" y="1979502"/>
                <a:ext cx="118107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GB" sz="1100" b="1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𝐋𝐨𝐠</m:t>
                          </m:r>
                        </m:e>
                        <m:sub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𝟏𝟎</m:t>
                          </m:r>
                        </m:sub>
                      </m:sSub>
                      <m:d>
                        <m:dPr>
                          <m:ctrlPr>
                            <a:rPr lang="en-GB" sz="1100" b="1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>
                            <m:sSubPr>
                              <m:ctrlPr>
                                <a:rPr lang="en-GB" sz="1100" b="1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𝐩</m:t>
                              </m:r>
                            </m:e>
                            <m:sub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𝐆</m:t>
                              </m:r>
                              <m:r>
                                <a:rPr lang="en-GB" sz="1100" b="1" i="0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𝐈𝐅𝐓</m:t>
                              </m:r>
                            </m:sub>
                          </m:sSub>
                        </m:e>
                      </m:d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EFB0FD9-5A1B-A1C7-FE27-1DC6F0FECC9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2583922" y="1979502"/>
                <a:ext cx="1181073" cy="261610"/>
              </a:xfrm>
              <a:prstGeom prst="rect">
                <a:avLst/>
              </a:prstGeom>
              <a:blipFill>
                <a:blip r:embed="rId11"/>
                <a:stretch>
                  <a:fillRect r="-2326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A6803A5-3E0C-E955-0F1D-0BA580F93831}"/>
                  </a:ext>
                </a:extLst>
              </p:cNvPr>
              <p:cNvSpPr txBox="1"/>
              <p:nvPr/>
            </p:nvSpPr>
            <p:spPr>
              <a:xfrm rot="16200000">
                <a:off x="5610290" y="1979502"/>
                <a:ext cx="118107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GB" sz="1100" b="1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𝐋𝐨𝐠</m:t>
                          </m:r>
                        </m:e>
                        <m:sub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𝟏𝟎</m:t>
                          </m:r>
                        </m:sub>
                      </m:sSub>
                      <m:d>
                        <m:dPr>
                          <m:ctrlPr>
                            <a:rPr lang="en-GB" sz="1100" b="1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>
                            <m:sSubPr>
                              <m:ctrlPr>
                                <a:rPr lang="en-GB" sz="1100" b="1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𝐩</m:t>
                              </m:r>
                            </m:e>
                            <m:sub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𝐆</m:t>
                              </m:r>
                              <m:r>
                                <a:rPr lang="en-GB" sz="1100" b="1" i="0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𝐈𝐅𝐓</m:t>
                              </m:r>
                            </m:sub>
                          </m:sSub>
                        </m:e>
                      </m:d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A6803A5-3E0C-E955-0F1D-0BA580F9383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5610290" y="1979502"/>
                <a:ext cx="1181073" cy="261610"/>
              </a:xfrm>
              <a:prstGeom prst="rect">
                <a:avLst/>
              </a:prstGeom>
              <a:blipFill>
                <a:blip r:embed="rId12"/>
                <a:stretch>
                  <a:fillRect r="-2326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FC4BC81-04CF-9950-1324-C51F2043ECF3}"/>
                  </a:ext>
                </a:extLst>
              </p:cNvPr>
              <p:cNvSpPr txBox="1"/>
              <p:nvPr/>
            </p:nvSpPr>
            <p:spPr>
              <a:xfrm rot="16200000">
                <a:off x="8608512" y="1979502"/>
                <a:ext cx="118107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GB" sz="1100" b="1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𝐋𝐨𝐠</m:t>
                          </m:r>
                        </m:e>
                        <m:sub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𝟏𝟎</m:t>
                          </m:r>
                        </m:sub>
                      </m:sSub>
                      <m:d>
                        <m:dPr>
                          <m:ctrlPr>
                            <a:rPr lang="en-GB" sz="1100" b="1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>
                            <m:sSubPr>
                              <m:ctrlPr>
                                <a:rPr lang="en-GB" sz="1100" b="1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𝐩</m:t>
                              </m:r>
                            </m:e>
                            <m:sub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𝐆</m:t>
                              </m:r>
                              <m:r>
                                <a:rPr lang="en-GB" sz="1100" b="1" i="0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𝐈𝐅𝐓</m:t>
                              </m:r>
                            </m:sub>
                          </m:sSub>
                        </m:e>
                      </m:d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FC4BC81-04CF-9950-1324-C51F2043ECF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8608512" y="1979502"/>
                <a:ext cx="1181073" cy="261610"/>
              </a:xfrm>
              <a:prstGeom prst="rect">
                <a:avLst/>
              </a:prstGeom>
              <a:blipFill>
                <a:blip r:embed="rId13"/>
                <a:stretch>
                  <a:fillRect r="-4762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1FA3AE3-3AEC-00F5-6EF0-A2237E82B04A}"/>
                  </a:ext>
                </a:extLst>
              </p:cNvPr>
              <p:cNvSpPr txBox="1"/>
              <p:nvPr/>
            </p:nvSpPr>
            <p:spPr>
              <a:xfrm rot="16200000">
                <a:off x="-427848" y="3888733"/>
                <a:ext cx="118107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GB" sz="1100" b="1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𝐋𝐨𝐠</m:t>
                          </m:r>
                        </m:e>
                        <m:sub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𝟏𝟎</m:t>
                          </m:r>
                        </m:sub>
                      </m:sSub>
                      <m:d>
                        <m:dPr>
                          <m:ctrlPr>
                            <a:rPr lang="en-GB" sz="1100" b="1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>
                            <m:sSubPr>
                              <m:ctrlPr>
                                <a:rPr lang="en-GB" sz="1100" b="1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𝐩</m:t>
                              </m:r>
                            </m:e>
                            <m:sub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𝐆</m:t>
                              </m:r>
                              <m:r>
                                <a:rPr lang="en-GB" sz="1100" b="1" i="0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𝐈𝐅𝐓</m:t>
                              </m:r>
                            </m:sub>
                          </m:sSub>
                        </m:e>
                      </m:d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1FA3AE3-3AEC-00F5-6EF0-A2237E82B04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-427848" y="3888733"/>
                <a:ext cx="1181073" cy="261610"/>
              </a:xfrm>
              <a:prstGeom prst="rect">
                <a:avLst/>
              </a:prstGeom>
              <a:blipFill>
                <a:blip r:embed="rId14"/>
                <a:stretch>
                  <a:fillRect r="-2326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489B16A0-DC0D-3608-8BA0-A4F4500CC777}"/>
                  </a:ext>
                </a:extLst>
              </p:cNvPr>
              <p:cNvSpPr txBox="1"/>
              <p:nvPr/>
            </p:nvSpPr>
            <p:spPr>
              <a:xfrm rot="16200000">
                <a:off x="2619346" y="3927612"/>
                <a:ext cx="118107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GB" sz="1100" b="1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𝐋𝐨𝐠</m:t>
                          </m:r>
                        </m:e>
                        <m:sub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𝟏𝟎</m:t>
                          </m:r>
                        </m:sub>
                      </m:sSub>
                      <m:d>
                        <m:dPr>
                          <m:ctrlPr>
                            <a:rPr lang="en-GB" sz="1100" b="1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>
                            <m:sSubPr>
                              <m:ctrlPr>
                                <a:rPr lang="en-GB" sz="1100" b="1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𝐩</m:t>
                              </m:r>
                            </m:e>
                            <m:sub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𝐆</m:t>
                              </m:r>
                              <m:r>
                                <a:rPr lang="en-GB" sz="1100" b="1" i="0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𝐈𝐅𝐓</m:t>
                              </m:r>
                            </m:sub>
                          </m:sSub>
                        </m:e>
                      </m:d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489B16A0-DC0D-3608-8BA0-A4F4500CC77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2619346" y="3927612"/>
                <a:ext cx="1181073" cy="261610"/>
              </a:xfrm>
              <a:prstGeom prst="rect">
                <a:avLst/>
              </a:prstGeom>
              <a:blipFill>
                <a:blip r:embed="rId15"/>
                <a:stretch>
                  <a:fillRect r="-2326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A023968-F004-DDFA-7CF0-B10E2B37CB75}"/>
                  </a:ext>
                </a:extLst>
              </p:cNvPr>
              <p:cNvSpPr txBox="1"/>
              <p:nvPr/>
            </p:nvSpPr>
            <p:spPr>
              <a:xfrm rot="16200000">
                <a:off x="5645521" y="3919769"/>
                <a:ext cx="118107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GB" sz="1100" b="1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𝐋𝐨𝐠</m:t>
                          </m:r>
                        </m:e>
                        <m:sub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𝟏𝟎</m:t>
                          </m:r>
                        </m:sub>
                      </m:sSub>
                      <m:d>
                        <m:dPr>
                          <m:ctrlPr>
                            <a:rPr lang="en-GB" sz="1100" b="1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>
                            <m:sSubPr>
                              <m:ctrlPr>
                                <a:rPr lang="en-GB" sz="1100" b="1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𝐩</m:t>
                              </m:r>
                            </m:e>
                            <m:sub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𝐆</m:t>
                              </m:r>
                              <m:r>
                                <a:rPr lang="en-GB" sz="1100" b="1" i="0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𝐈𝐅𝐓</m:t>
                              </m:r>
                            </m:sub>
                          </m:sSub>
                        </m:e>
                      </m:d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A023968-F004-DDFA-7CF0-B10E2B37CB7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5645521" y="3919769"/>
                <a:ext cx="1181073" cy="261610"/>
              </a:xfrm>
              <a:prstGeom prst="rect">
                <a:avLst/>
              </a:prstGeom>
              <a:blipFill>
                <a:blip r:embed="rId16"/>
                <a:stretch>
                  <a:fillRect r="-4762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5478C15-479F-F84F-75C1-E691EAFF6D2C}"/>
                  </a:ext>
                </a:extLst>
              </p:cNvPr>
              <p:cNvSpPr txBox="1"/>
              <p:nvPr/>
            </p:nvSpPr>
            <p:spPr>
              <a:xfrm rot="16200000">
                <a:off x="8615829" y="3927613"/>
                <a:ext cx="1181073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GB" sz="1100" b="1" i="1" smtClean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𝐋𝐨𝐠</m:t>
                          </m:r>
                        </m:e>
                        <m:sub>
                          <m:r>
                            <a:rPr lang="en-GB" sz="1100" b="1" i="0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  <m:t>𝟏𝟎</m:t>
                          </m:r>
                        </m:sub>
                      </m:sSub>
                      <m:d>
                        <m:dPr>
                          <m:ctrlPr>
                            <a:rPr lang="en-GB" sz="1100" b="1" i="1">
                              <a:solidFill>
                                <a:schemeClr val="tx1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sSub>
                            <m:sSubPr>
                              <m:ctrlPr>
                                <a:rPr lang="en-GB" sz="1100" b="1" i="1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𝐩</m:t>
                              </m:r>
                            </m:e>
                            <m:sub>
                              <m:r>
                                <a:rPr lang="en-GB" sz="1100" b="1" i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𝐆</m:t>
                              </m:r>
                              <m:r>
                                <a:rPr lang="en-GB" sz="1100" b="1" i="0" smtClean="0">
                                  <a:solidFill>
                                    <a:schemeClr val="tx1"/>
                                  </a:solidFill>
                                  <a:latin typeface="Cambria Math" panose="02040503050406030204" pitchFamily="18" charset="0"/>
                                </a:rPr>
                                <m:t>𝐈𝐅𝐓</m:t>
                              </m:r>
                            </m:sub>
                          </m:sSub>
                        </m:e>
                      </m:d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5478C15-479F-F84F-75C1-E691EAFF6D2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8615829" y="3927613"/>
                <a:ext cx="1181073" cy="261610"/>
              </a:xfrm>
              <a:prstGeom prst="rect">
                <a:avLst/>
              </a:prstGeom>
              <a:blipFill>
                <a:blip r:embed="rId17"/>
                <a:stretch>
                  <a:fillRect r="-2326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D401AEC-6019-1216-781C-C9A7267F90DF}"/>
                  </a:ext>
                </a:extLst>
              </p:cNvPr>
              <p:cNvSpPr txBox="1"/>
              <p:nvPr/>
            </p:nvSpPr>
            <p:spPr>
              <a:xfrm>
                <a:off x="1109555" y="229524"/>
                <a:ext cx="10073975" cy="923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dirty="0"/>
                  <a:t>Boxplots resulting from thousand random permutations of significant SNPs by GIFT</a:t>
                </a:r>
              </a:p>
              <a:p>
                <a:pPr algn="ctr"/>
                <a:r>
                  <a:rPr lang="en-GB" dirty="0"/>
                  <a:t>The initial significant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GB" sz="1800" i="1" smtClean="0">
                            <a:solidFill>
                              <a:schemeClr val="tx1"/>
                            </a:solidFill>
                          </a:rPr>
                        </m:ctrlPr>
                      </m:sSubPr>
                      <m:e>
                        <m:r>
                          <a:rPr lang="en-GB" sz="1800" b="0" i="0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−</m:t>
                        </m:r>
                        <m:r>
                          <m:rPr>
                            <m:sty m:val="p"/>
                          </m:rPr>
                          <a:rPr lang="en-GB" sz="1800" b="0" i="0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Log</m:t>
                        </m:r>
                      </m:e>
                      <m:sub>
                        <m:r>
                          <a:rPr lang="en-GB" sz="1800" b="0" i="0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10</m:t>
                        </m:r>
                      </m:sub>
                    </m:sSub>
                    <m:d>
                      <m:dPr>
                        <m:ctrlPr>
                          <a:rPr lang="en-GB" sz="1800" i="1">
                            <a:solidFill>
                              <a:schemeClr val="tx1"/>
                            </a:solidFill>
                          </a:rPr>
                        </m:ctrlPr>
                      </m:dPr>
                      <m:e>
                        <m:sSub>
                          <m:sSubPr>
                            <m:ctrlPr>
                              <a:rPr lang="en-GB" sz="1800" i="1">
                                <a:solidFill>
                                  <a:schemeClr val="tx1"/>
                                </a:solidFill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n-GB" sz="1800" b="0" i="0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p</m:t>
                            </m:r>
                          </m:e>
                          <m:sub>
                            <m:r>
                              <m:rPr>
                                <m:sty m:val="p"/>
                              </m:rPr>
                              <a:rPr lang="en-GB" sz="1800" b="0" i="0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GIFT</m:t>
                            </m:r>
                          </m:sub>
                        </m:sSub>
                      </m:e>
                    </m:d>
                  </m:oMath>
                </a14:m>
                <a:r>
                  <a:rPr lang="en-GB" dirty="0"/>
                  <a:t>-value for each SNP prior to permutation is given by the blue disc</a:t>
                </a:r>
              </a:p>
              <a:p>
                <a:pPr algn="ctr"/>
                <a:r>
                  <a:rPr lang="en-GB" dirty="0"/>
                  <a:t>The red dashed line is the threshold used by GIFT (see Fig.7B – Main text)</a:t>
                </a:r>
              </a:p>
            </p:txBody>
          </p:sp>
        </mc:Choice>
        <mc:Fallback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D401AEC-6019-1216-781C-C9A7267F90D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109555" y="229524"/>
                <a:ext cx="10073975" cy="923330"/>
              </a:xfrm>
              <a:prstGeom prst="rect">
                <a:avLst/>
              </a:prstGeom>
              <a:blipFill>
                <a:blip r:embed="rId18"/>
                <a:stretch>
                  <a:fillRect t="-3311" b="-10596"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3FE8F81-F1DA-08B3-18E5-82DCE65380FF}"/>
                  </a:ext>
                </a:extLst>
              </p:cNvPr>
              <p:cNvSpPr txBox="1"/>
              <p:nvPr/>
            </p:nvSpPr>
            <p:spPr>
              <a:xfrm>
                <a:off x="1192921" y="3167390"/>
                <a:ext cx="79415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𝐒𝐍𝐏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𝐈𝐝</m:t>
                      </m:r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3FE8F81-F1DA-08B3-18E5-82DCE65380FF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192921" y="3167390"/>
                <a:ext cx="794157" cy="261610"/>
              </a:xfrm>
              <a:prstGeom prst="rect">
                <a:avLst/>
              </a:prstGeom>
              <a:blipFill>
                <a:blip r:embed="rId1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76DC17F-EA42-164C-50AD-3086E5A33517}"/>
                  </a:ext>
                </a:extLst>
              </p:cNvPr>
              <p:cNvSpPr txBox="1"/>
              <p:nvPr/>
            </p:nvSpPr>
            <p:spPr>
              <a:xfrm>
                <a:off x="4314819" y="3167390"/>
                <a:ext cx="79415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𝐒𝐍𝐏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𝐈𝐝</m:t>
                      </m:r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76DC17F-EA42-164C-50AD-3086E5A3351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314819" y="3167390"/>
                <a:ext cx="794157" cy="261610"/>
              </a:xfrm>
              <a:prstGeom prst="rect">
                <a:avLst/>
              </a:prstGeom>
              <a:blipFill>
                <a:blip r:embed="rId1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98E149A-8396-7BA7-353F-BCA042F98885}"/>
                  </a:ext>
                </a:extLst>
              </p:cNvPr>
              <p:cNvSpPr txBox="1"/>
              <p:nvPr/>
            </p:nvSpPr>
            <p:spPr>
              <a:xfrm>
                <a:off x="7444747" y="3167390"/>
                <a:ext cx="79415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𝐒𝐍𝐏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𝐈𝐝</m:t>
                      </m:r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98E149A-8396-7BA7-353F-BCA042F98885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444747" y="3167390"/>
                <a:ext cx="794157" cy="261610"/>
              </a:xfrm>
              <a:prstGeom prst="rect">
                <a:avLst/>
              </a:prstGeom>
              <a:blipFill>
                <a:blip r:embed="rId2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3998E1DD-765E-40FA-3DF2-F0991FEA7510}"/>
                  </a:ext>
                </a:extLst>
              </p:cNvPr>
              <p:cNvSpPr txBox="1"/>
              <p:nvPr/>
            </p:nvSpPr>
            <p:spPr>
              <a:xfrm>
                <a:off x="10389374" y="3167390"/>
                <a:ext cx="79415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𝐒𝐍𝐏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𝐈𝐝</m:t>
                      </m:r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3998E1DD-765E-40FA-3DF2-F0991FEA751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389374" y="3167390"/>
                <a:ext cx="794157" cy="261610"/>
              </a:xfrm>
              <a:prstGeom prst="rect">
                <a:avLst/>
              </a:prstGeom>
              <a:blipFill>
                <a:blip r:embed="rId2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B76B122D-C6E4-2E69-94CF-9126B39DD4A2}"/>
                  </a:ext>
                </a:extLst>
              </p:cNvPr>
              <p:cNvSpPr txBox="1"/>
              <p:nvPr/>
            </p:nvSpPr>
            <p:spPr>
              <a:xfrm>
                <a:off x="1200238" y="5156637"/>
                <a:ext cx="79415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𝐒𝐍𝐏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𝐈𝐝</m:t>
                      </m:r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B76B122D-C6E4-2E69-94CF-9126B39DD4A2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200238" y="5156637"/>
                <a:ext cx="794157" cy="261610"/>
              </a:xfrm>
              <a:prstGeom prst="rect">
                <a:avLst/>
              </a:prstGeom>
              <a:blipFill>
                <a:blip r:embed="rId1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8C3E3392-EBCF-8F27-EE50-A0CDEBDBE28B}"/>
                  </a:ext>
                </a:extLst>
              </p:cNvPr>
              <p:cNvSpPr txBox="1"/>
              <p:nvPr/>
            </p:nvSpPr>
            <p:spPr>
              <a:xfrm>
                <a:off x="4322136" y="5156637"/>
                <a:ext cx="79415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𝐒𝐍𝐏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𝐈𝐝</m:t>
                      </m:r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8C3E3392-EBCF-8F27-EE50-A0CDEBDBE28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322136" y="5156637"/>
                <a:ext cx="794157" cy="261610"/>
              </a:xfrm>
              <a:prstGeom prst="rect">
                <a:avLst/>
              </a:prstGeom>
              <a:blipFill>
                <a:blip r:embed="rId19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3173AAF-DB2E-AD10-5660-6002F559FEA3}"/>
                  </a:ext>
                </a:extLst>
              </p:cNvPr>
              <p:cNvSpPr txBox="1"/>
              <p:nvPr/>
            </p:nvSpPr>
            <p:spPr>
              <a:xfrm>
                <a:off x="7452064" y="5156637"/>
                <a:ext cx="79415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𝐒𝐍𝐏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𝐈𝐝</m:t>
                      </m:r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3173AAF-DB2E-AD10-5660-6002F559FEA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452064" y="5156637"/>
                <a:ext cx="794157" cy="261610"/>
              </a:xfrm>
              <a:prstGeom prst="rect">
                <a:avLst/>
              </a:prstGeom>
              <a:blipFill>
                <a:blip r:embed="rId20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:a14="http://schemas.microsoft.com/office/drawing/2010/main" Requires="a14"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0340353-CE1A-CBD5-2EDA-60E856DCF936}"/>
                  </a:ext>
                </a:extLst>
              </p:cNvPr>
              <p:cNvSpPr txBox="1"/>
              <p:nvPr/>
            </p:nvSpPr>
            <p:spPr>
              <a:xfrm>
                <a:off x="10396691" y="5156637"/>
                <a:ext cx="79415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𝐒𝐍𝐏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en-GB" sz="1100" b="1" i="0" smtClean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</a:rPr>
                        <m:t>𝐈𝐝</m:t>
                      </m:r>
                    </m:oMath>
                  </m:oMathPara>
                </a14:m>
                <a:endParaRPr lang="en-GB" sz="1100" b="1" dirty="0">
                  <a:solidFill>
                    <a:schemeClr val="tx1"/>
                  </a:solidFill>
                </a:endParaRPr>
              </a:p>
            </p:txBody>
          </p:sp>
        </mc:Choice>
        <mc:Fallback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0340353-CE1A-CBD5-2EDA-60E856DCF93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396691" y="5156637"/>
                <a:ext cx="794157" cy="261610"/>
              </a:xfrm>
              <a:prstGeom prst="rect">
                <a:avLst/>
              </a:prstGeom>
              <a:blipFill>
                <a:blip r:embed="rId21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GB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6332825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9896F9C-CEC9-946D-552B-5303CB3CCF1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5875"/>
          <a:stretch/>
        </p:blipFill>
        <p:spPr>
          <a:xfrm>
            <a:off x="2086885" y="1990590"/>
            <a:ext cx="3024000" cy="1817100"/>
          </a:xfrm>
          <a:prstGeom prst="rect">
            <a:avLst/>
          </a:prstGeom>
        </p:spPr>
      </p:pic>
      <p:pic>
        <p:nvPicPr>
          <p:cNvPr id="3074" name="Picture 2">
            <a:extLst>
              <a:ext uri="{FF2B5EF4-FFF2-40B4-BE49-F238E27FC236}">
                <a16:creationId xmlns:a16="http://schemas.microsoft.com/office/drawing/2014/main" id="{7269BA90-CDEE-5C61-847A-8F72478FFBC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875"/>
          <a:stretch/>
        </p:blipFill>
        <p:spPr bwMode="auto">
          <a:xfrm>
            <a:off x="7147604" y="2009709"/>
            <a:ext cx="3024000" cy="1817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183616A-FC7D-CFE3-0B3F-65FA6E067F66}"/>
              </a:ext>
            </a:extLst>
          </p:cNvPr>
          <p:cNvSpPr txBox="1"/>
          <p:nvPr/>
        </p:nvSpPr>
        <p:spPr>
          <a:xfrm>
            <a:off x="3339805" y="3546080"/>
            <a:ext cx="105028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b="1" dirty="0"/>
              <a:t>Median (Med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5819648-747F-DD2A-4FD1-C052B10FB7F6}"/>
              </a:ext>
            </a:extLst>
          </p:cNvPr>
          <p:cNvSpPr txBox="1"/>
          <p:nvPr/>
        </p:nvSpPr>
        <p:spPr>
          <a:xfrm>
            <a:off x="7968549" y="3565199"/>
            <a:ext cx="1670650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b="1" dirty="0"/>
              <a:t>Interquartile range (</a:t>
            </a:r>
            <a:r>
              <a:rPr lang="en-GB" sz="1100" b="1" dirty="0" err="1"/>
              <a:t>Iqr</a:t>
            </a:r>
            <a:r>
              <a:rPr lang="en-GB" sz="1100" b="1" dirty="0"/>
              <a:t>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6EF1C25-630B-B1FF-6EE4-178CEC29B718}"/>
              </a:ext>
            </a:extLst>
          </p:cNvPr>
          <p:cNvSpPr txBox="1"/>
          <p:nvPr/>
        </p:nvSpPr>
        <p:spPr>
          <a:xfrm rot="16200000">
            <a:off x="1691496" y="2596884"/>
            <a:ext cx="86113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b="1" dirty="0"/>
              <a:t>Frequenc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2AEE0A1-0111-9813-495E-EEBEB57854C0}"/>
              </a:ext>
            </a:extLst>
          </p:cNvPr>
          <p:cNvSpPr txBox="1"/>
          <p:nvPr/>
        </p:nvSpPr>
        <p:spPr>
          <a:xfrm rot="16200000">
            <a:off x="6752216" y="2616003"/>
            <a:ext cx="861133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b="1" dirty="0"/>
              <a:t>Frequenc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5406500-741E-7863-F628-4AA398FFDFC7}"/>
              </a:ext>
            </a:extLst>
          </p:cNvPr>
          <p:cNvSpPr txBox="1"/>
          <p:nvPr/>
        </p:nvSpPr>
        <p:spPr>
          <a:xfrm>
            <a:off x="1898396" y="1566153"/>
            <a:ext cx="3024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dirty="0"/>
              <a:t>Distribution of medians of significant SNPs upon thousand random permutations for eac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03C4ED-A639-FD60-05CD-5936CCBEA438}"/>
              </a:ext>
            </a:extLst>
          </p:cNvPr>
          <p:cNvSpPr txBox="1"/>
          <p:nvPr/>
        </p:nvSpPr>
        <p:spPr>
          <a:xfrm>
            <a:off x="6966275" y="1590970"/>
            <a:ext cx="338665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dirty="0"/>
              <a:t>Distribution of interquartile range of significant SNPs upon thousand random permutations for each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9DE6DC0-E431-DAA7-701C-509A0F4F88AB}"/>
              </a:ext>
            </a:extLst>
          </p:cNvPr>
          <p:cNvSpPr txBox="1"/>
          <p:nvPr/>
        </p:nvSpPr>
        <p:spPr>
          <a:xfrm>
            <a:off x="1368864" y="451207"/>
            <a:ext cx="95699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Statistics of boxplots resulting from thousand random permutations of significant SNPs by GIF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F022662-3946-69E4-BA71-193BD6D22D79}"/>
              </a:ext>
            </a:extLst>
          </p:cNvPr>
          <p:cNvSpPr txBox="1"/>
          <p:nvPr/>
        </p:nvSpPr>
        <p:spPr>
          <a:xfrm>
            <a:off x="7313588" y="3923134"/>
            <a:ext cx="1838965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Minimal value of </a:t>
            </a:r>
            <a:r>
              <a:rPr lang="en-GB" sz="1100" dirty="0" err="1"/>
              <a:t>Iqr</a:t>
            </a:r>
            <a:r>
              <a:rPr lang="en-GB" sz="1100" dirty="0"/>
              <a:t>: 2.174</a:t>
            </a:r>
          </a:p>
          <a:p>
            <a:r>
              <a:rPr lang="en-GB" sz="1100" dirty="0"/>
              <a:t>1</a:t>
            </a:r>
            <a:r>
              <a:rPr lang="en-GB" sz="1100" baseline="30000" dirty="0"/>
              <a:t>st</a:t>
            </a:r>
            <a:r>
              <a:rPr lang="en-GB" sz="1100" dirty="0"/>
              <a:t> quantile of </a:t>
            </a:r>
            <a:r>
              <a:rPr lang="en-GB" sz="1100" dirty="0" err="1"/>
              <a:t>Iqr</a:t>
            </a:r>
            <a:r>
              <a:rPr lang="en-GB" sz="1100" dirty="0"/>
              <a:t>: 2.444</a:t>
            </a:r>
          </a:p>
          <a:p>
            <a:r>
              <a:rPr lang="en-GB" sz="1100" dirty="0"/>
              <a:t>Median of </a:t>
            </a:r>
            <a:r>
              <a:rPr lang="en-GB" sz="1100" dirty="0" err="1"/>
              <a:t>Iqr</a:t>
            </a:r>
            <a:r>
              <a:rPr lang="en-GB" sz="1100" dirty="0"/>
              <a:t>: 2.525</a:t>
            </a:r>
          </a:p>
          <a:p>
            <a:r>
              <a:rPr lang="en-GB" sz="1100" dirty="0"/>
              <a:t>3</a:t>
            </a:r>
            <a:r>
              <a:rPr lang="en-GB" sz="1100" baseline="30000" dirty="0"/>
              <a:t>rd</a:t>
            </a:r>
            <a:r>
              <a:rPr lang="en-GB" sz="1100" dirty="0"/>
              <a:t> quantile of </a:t>
            </a:r>
            <a:r>
              <a:rPr lang="en-GB" sz="1100" dirty="0" err="1"/>
              <a:t>Iqr</a:t>
            </a:r>
            <a:r>
              <a:rPr lang="en-GB" sz="1100" dirty="0"/>
              <a:t>: 2.615</a:t>
            </a:r>
          </a:p>
          <a:p>
            <a:r>
              <a:rPr lang="en-GB" sz="1100" dirty="0"/>
              <a:t>Maximal value of </a:t>
            </a:r>
            <a:r>
              <a:rPr lang="en-GB" sz="1100" dirty="0" err="1"/>
              <a:t>Iqr</a:t>
            </a:r>
            <a:r>
              <a:rPr lang="en-GB" sz="1100" dirty="0"/>
              <a:t>: 2.934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B367F3E-21A6-3F16-2B6D-4275707432CA}"/>
              </a:ext>
            </a:extLst>
          </p:cNvPr>
          <p:cNvSpPr txBox="1"/>
          <p:nvPr/>
        </p:nvSpPr>
        <p:spPr>
          <a:xfrm>
            <a:off x="7313588" y="4905336"/>
            <a:ext cx="208422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Mean of </a:t>
            </a:r>
            <a:r>
              <a:rPr lang="en-GB" sz="1100" dirty="0" err="1"/>
              <a:t>Iqr</a:t>
            </a:r>
            <a:r>
              <a:rPr lang="en-GB" sz="1100" dirty="0"/>
              <a:t>:  2.530</a:t>
            </a:r>
          </a:p>
          <a:p>
            <a:r>
              <a:rPr lang="en-GB" sz="1100" dirty="0"/>
              <a:t>Standard deviation of </a:t>
            </a:r>
            <a:r>
              <a:rPr lang="en-GB" sz="1100" dirty="0" err="1"/>
              <a:t>Iqr</a:t>
            </a:r>
            <a:r>
              <a:rPr lang="en-GB" sz="1100" dirty="0"/>
              <a:t>: 0.12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2B3AF2A-CBC5-C7BA-235C-3DDF641440F4}"/>
              </a:ext>
            </a:extLst>
          </p:cNvPr>
          <p:cNvSpPr txBox="1"/>
          <p:nvPr/>
        </p:nvSpPr>
        <p:spPr>
          <a:xfrm>
            <a:off x="2252868" y="3918522"/>
            <a:ext cx="1941557" cy="9387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Minimal value of Med: 4.680</a:t>
            </a:r>
          </a:p>
          <a:p>
            <a:r>
              <a:rPr lang="en-GB" sz="1100" dirty="0"/>
              <a:t>1</a:t>
            </a:r>
            <a:r>
              <a:rPr lang="en-GB" sz="1100" baseline="30000" dirty="0"/>
              <a:t>st</a:t>
            </a:r>
            <a:r>
              <a:rPr lang="en-GB" sz="1100" dirty="0"/>
              <a:t> quantile of Med: 4.871</a:t>
            </a:r>
          </a:p>
          <a:p>
            <a:r>
              <a:rPr lang="en-GB" sz="1100" dirty="0"/>
              <a:t>Median of Med: 4.933</a:t>
            </a:r>
          </a:p>
          <a:p>
            <a:r>
              <a:rPr lang="en-GB" sz="1100" dirty="0"/>
              <a:t>3</a:t>
            </a:r>
            <a:r>
              <a:rPr lang="en-GB" sz="1100" baseline="30000" dirty="0"/>
              <a:t>rd</a:t>
            </a:r>
            <a:r>
              <a:rPr lang="en-GB" sz="1100" dirty="0"/>
              <a:t> quantile of Med: 4.989</a:t>
            </a:r>
          </a:p>
          <a:p>
            <a:r>
              <a:rPr lang="en-GB" sz="1100" dirty="0"/>
              <a:t>Maximal value of Med: 5.157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ED83846-8F93-EA50-0345-EC1B2BBD53CE}"/>
              </a:ext>
            </a:extLst>
          </p:cNvPr>
          <p:cNvSpPr txBox="1"/>
          <p:nvPr/>
        </p:nvSpPr>
        <p:spPr>
          <a:xfrm>
            <a:off x="2252868" y="4900724"/>
            <a:ext cx="218681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Mean of Med:  4.931</a:t>
            </a:r>
          </a:p>
          <a:p>
            <a:r>
              <a:rPr lang="en-GB" sz="1100" dirty="0"/>
              <a:t>Standard deviation of Med: 0.087</a:t>
            </a:r>
          </a:p>
        </p:txBody>
      </p:sp>
    </p:spTree>
    <p:extLst>
      <p:ext uri="{BB962C8B-B14F-4D97-AF65-F5344CB8AC3E}">
        <p14:creationId xmlns:p14="http://schemas.microsoft.com/office/powerpoint/2010/main" val="2593004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210</Words>
  <Application>Microsoft Office PowerPoint</Application>
  <PresentationFormat>Widescreen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mbria Math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yril Rauch (staff)</dc:creator>
  <cp:lastModifiedBy>Cyril Rauch (staff)</cp:lastModifiedBy>
  <cp:revision>1</cp:revision>
  <dcterms:created xsi:type="dcterms:W3CDTF">2024-07-18T13:36:26Z</dcterms:created>
  <dcterms:modified xsi:type="dcterms:W3CDTF">2024-07-18T15:11:35Z</dcterms:modified>
</cp:coreProperties>
</file>